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51" autoAdjust="0"/>
    <p:restoredTop sz="94660"/>
  </p:normalViewPr>
  <p:slideViewPr>
    <p:cSldViewPr snapToGrid="0">
      <p:cViewPr varScale="1">
        <p:scale>
          <a:sx n="74" d="100"/>
          <a:sy n="74" d="100"/>
        </p:scale>
        <p:origin x="91" y="36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03CD2-4235-486F-BD7D-370DC4866649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67DA2-AD7B-4FD4-BD02-7D004EE16A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66896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03CD2-4235-486F-BD7D-370DC4866649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67DA2-AD7B-4FD4-BD02-7D004EE16A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9362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03CD2-4235-486F-BD7D-370DC4866649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67DA2-AD7B-4FD4-BD02-7D004EE16A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321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03CD2-4235-486F-BD7D-370DC4866649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67DA2-AD7B-4FD4-BD02-7D004EE16A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39445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03CD2-4235-486F-BD7D-370DC4866649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67DA2-AD7B-4FD4-BD02-7D004EE16A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16886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03CD2-4235-486F-BD7D-370DC4866649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67DA2-AD7B-4FD4-BD02-7D004EE16A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9518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03CD2-4235-486F-BD7D-370DC4866649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67DA2-AD7B-4FD4-BD02-7D004EE16A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79662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03CD2-4235-486F-BD7D-370DC4866649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67DA2-AD7B-4FD4-BD02-7D004EE16A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33915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03CD2-4235-486F-BD7D-370DC4866649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67DA2-AD7B-4FD4-BD02-7D004EE16A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8850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03CD2-4235-486F-BD7D-370DC4866649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67DA2-AD7B-4FD4-BD02-7D004EE16A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25112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03CD2-4235-486F-BD7D-370DC4866649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67DA2-AD7B-4FD4-BD02-7D004EE16A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78039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D03CD2-4235-486F-BD7D-370DC4866649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467DA2-AD7B-4FD4-BD02-7D004EE16A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9974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9B3EEDFB-8BBC-43D5-B908-764DB2F439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2588" y="303424"/>
            <a:ext cx="6900823" cy="5170276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0E960C9-E435-44DE-8FF6-BCA2C7F3F0B6}"/>
              </a:ext>
            </a:extLst>
          </p:cNvPr>
          <p:cNvSpPr txBox="1"/>
          <p:nvPr/>
        </p:nvSpPr>
        <p:spPr>
          <a:xfrm>
            <a:off x="3262745" y="5473700"/>
            <a:ext cx="404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. Oba et al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B3316D23-11C0-4F18-8B58-B4C6BE487109}"/>
              </a:ext>
            </a:extLst>
          </p:cNvPr>
          <p:cNvSpPr/>
          <p:nvPr/>
        </p:nvSpPr>
        <p:spPr>
          <a:xfrm>
            <a:off x="285030" y="5914856"/>
            <a:ext cx="953140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ntranuclear inclusion body in the kidney medulla cells of a pig who was positive for PAdV.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Haematoxyli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nd eosin (HE) stain. The scale bar represents 20μm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46586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</TotalTime>
  <Words>39</Words>
  <Application>Microsoft Office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等线</vt:lpstr>
      <vt:lpstr>Arial</vt:lpstr>
      <vt:lpstr>Calibri</vt:lpstr>
      <vt:lpstr>Calibri Light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長井 誠</dc:creator>
  <cp:lastModifiedBy>MDPI</cp:lastModifiedBy>
  <cp:revision>3</cp:revision>
  <dcterms:created xsi:type="dcterms:W3CDTF">2022-09-24T11:34:23Z</dcterms:created>
  <dcterms:modified xsi:type="dcterms:W3CDTF">2022-10-29T11:03:29Z</dcterms:modified>
</cp:coreProperties>
</file>